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58" r:id="rId3"/>
    <p:sldId id="264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360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3F8F6B-4EB3-4EF6-8849-9FCCD0D18D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0D74F84-E16F-4876-A153-136A4E4D09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29752D-0B07-48AB-8482-11F2FFDCD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534941-FEB3-48C2-B480-9D057689D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A9D12E-8890-435A-839C-A1B458FE1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779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2C9D7D-B232-4CAF-B73F-57022E250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045E9E3-2F0F-4972-B0E7-EB0290454F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4080AB-3B13-4D92-909E-D62640CC9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13E402-D02F-40E7-8745-744B800DF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A20D79-8980-4DEA-AC91-D8F2E0283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4366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7DB22E2-2CC3-4EB8-927D-CC5377B9AB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7D6D286-F559-4856-8EBF-E0E6C76ED2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DFD67E-D336-4516-9DA6-A41541F74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505351-F2AE-4688-B40D-AE9EFDC33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A07CD1-D841-42DB-96D6-B65C45814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0582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1C342F-25F8-44AD-BB3F-F2989904C7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A539AA-4282-4267-AFCB-F0A9EB8FA2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8DF232-B577-40E2-B1A7-9F9E03547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2D6445-ADBD-412B-AA1B-BC6A0C58A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6309C3-7B9E-49DA-95FF-6CA3FF740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734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08270D-1885-443B-9496-2F6DF1031E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4D0BF2-4440-4A22-BEE6-A7247982F4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23920F-1758-42B6-BA53-D99FF0CB0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64222A-7314-4F74-BC5D-31E6BBE39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A69512-733E-4AB3-9EF5-7C637FC31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09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740A6D-F87E-46CF-9694-1C6EBAFA1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3C2542-0E00-478B-88BA-0D2693C5D9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4610D14-54CA-4CBC-B60F-EF046D928B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0DC53B5-7999-44D5-B7EF-7C4236BD6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8F064C-033B-4684-995D-A7B1BAC82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A96D72-F98B-40F1-8818-54C6BEA16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5559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0407F2-739F-4ED5-98F6-AE776136EA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120E53-C864-4DD9-B448-AC83E767E6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08D688-F22A-4B6D-8579-ECD118D75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AB2EE06-E9B1-43AF-8CCB-BB0C591414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F093222-45E5-47E2-95EB-5B18C7A77B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CE10D96-4EEC-43CA-84F7-876BCD20E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670B239-9CF9-4D59-B5F4-CBD79E5C7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D939353-5A08-431F-88BC-9EB693F51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6244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0B7CB0-F7EC-4066-9AC3-03339A6B4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03A4444-64A3-4800-AA28-E2426D2D6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201A2FF-5019-41E0-B414-ECB29DC40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4E00947-15E9-4805-A3CD-B24F1F323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7820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32889BB-D61D-4CBA-9BF2-88FE44790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1935367-04E1-457E-9019-E6734C39C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F9CBCA5-A95D-43A8-BBD1-6F14BB006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9210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EFFA55-F878-4CCD-BEE2-6E90A6FD0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D682135-A0F1-4017-8F08-5642501479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E6971F4-F83D-4F79-AB99-7CCB8686E8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F688F69-0D29-4D54-A7E3-19F6B6BA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E7F19FD-823B-4B04-9076-7DE299AE1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3E25402-2E53-466E-A30B-6D0CEE7A7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7436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B41EB8-4279-4EDD-8C8F-1D85AAF84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CC7A3AA-ADBF-46B5-ABB7-B9E88424BA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08CCC6-F33A-4242-88B2-EEC2DAC5A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6A6B9D5-BCB3-47EA-9AB9-8B00D76E6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E383AB-807E-404D-9574-E8970F210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B4DFA1-14FF-4636-9397-107D9FB7B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063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9D279F0-728B-411F-AA27-8606A7B0B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BF3E12-701F-446F-A37D-415FC0E40A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1D3F19-F7BD-4549-AE24-917AA10D3D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FD26B-DABF-4F63-AC3E-82276FCE9717}" type="datetimeFigureOut">
              <a:rPr lang="zh-CN" altLang="en-US" smtClean="0"/>
              <a:t>2024/05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F1771C-10B4-47A0-9F3D-D55CF3191C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179CBB-4C34-4633-98F5-900B896834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41364-4248-4996-A505-6391FBFCF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99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20F09EAD-5831-465B-AD47-9AA4F2C76A33}"/>
              </a:ext>
            </a:extLst>
          </p:cNvPr>
          <p:cNvGrpSpPr/>
          <p:nvPr/>
        </p:nvGrpSpPr>
        <p:grpSpPr>
          <a:xfrm>
            <a:off x="2529840" y="1036320"/>
            <a:ext cx="6406896" cy="5492496"/>
            <a:chOff x="2243328" y="182499"/>
            <a:chExt cx="7632192" cy="6254496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3D08FC7-29DD-42BE-9A88-F28DA1763A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3" t="3911" r="3446" b="4889"/>
            <a:stretch/>
          </p:blipFill>
          <p:spPr>
            <a:xfrm>
              <a:off x="2243328" y="182499"/>
              <a:ext cx="7632192" cy="6254496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3AF8CD54-4F20-47F4-80A2-53A86A070E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69326" y="792049"/>
              <a:ext cx="530398" cy="1140051"/>
            </a:xfrm>
            <a:prstGeom prst="rect">
              <a:avLst/>
            </a:prstGeom>
          </p:spPr>
        </p:pic>
      </p:grpSp>
      <p:sp>
        <p:nvSpPr>
          <p:cNvPr id="7" name="矩形 6">
            <a:extLst>
              <a:ext uri="{FF2B5EF4-FFF2-40B4-BE49-F238E27FC236}">
                <a16:creationId xmlns:a16="http://schemas.microsoft.com/office/drawing/2014/main" id="{EB1E661B-C776-442A-83D9-C1D0C6892187}"/>
              </a:ext>
            </a:extLst>
          </p:cNvPr>
          <p:cNvSpPr/>
          <p:nvPr/>
        </p:nvSpPr>
        <p:spPr>
          <a:xfrm>
            <a:off x="3768289" y="397502"/>
            <a:ext cx="29674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kern="100" dirty="0">
                <a:latin typeface="Times New Roman" panose="02020603050405020304" pitchFamily="18" charset="0"/>
              </a:rPr>
              <a:t>Figure S1. Relevance analysi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29918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9100D232-6C4E-465F-8686-11E1E60742CE}"/>
              </a:ext>
            </a:extLst>
          </p:cNvPr>
          <p:cNvSpPr/>
          <p:nvPr/>
        </p:nvSpPr>
        <p:spPr>
          <a:xfrm>
            <a:off x="2129946" y="610862"/>
            <a:ext cx="71311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kern="100" dirty="0">
                <a:latin typeface="Times New Roman" panose="02020603050405020304" pitchFamily="18" charset="0"/>
              </a:rPr>
              <a:t>Figure S2. Changes in rice gene expression profile among different groups.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A792999-C23C-4B7D-B0E5-B89BC94BD0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188" y="1426464"/>
            <a:ext cx="6445980" cy="4629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82591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A24C7CB-42A0-4D37-B768-97156E45C4E6}"/>
              </a:ext>
            </a:extLst>
          </p:cNvPr>
          <p:cNvGrpSpPr/>
          <p:nvPr/>
        </p:nvGrpSpPr>
        <p:grpSpPr>
          <a:xfrm>
            <a:off x="1557898" y="688832"/>
            <a:ext cx="9648693" cy="6152959"/>
            <a:chOff x="1484746" y="81327"/>
            <a:chExt cx="9648693" cy="615295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FF2632B-116B-4910-AF01-BEEDEE805F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4746" y="81328"/>
              <a:ext cx="2846305" cy="3024743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39899078-EBEB-4169-AB29-9C150DF11FE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76577" y="81327"/>
              <a:ext cx="4156862" cy="3024743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7A4D6627-9C92-4DE0-88D8-35631712B5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2012" y="81328"/>
              <a:ext cx="2502109" cy="3024743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87E0146A-5811-4607-B046-DF09381F99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4746" y="3209543"/>
              <a:ext cx="2846305" cy="3024743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DF9495A9-11DA-4A85-B559-9C206DB053C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76577" y="3209543"/>
              <a:ext cx="4156862" cy="3024743"/>
            </a:xfrm>
            <a:prstGeom prst="rect">
              <a:avLst/>
            </a:prstGeom>
          </p:spPr>
        </p:pic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BBB0162E-6C82-4AA1-BDB9-98914261FB2A}"/>
                </a:ext>
              </a:extLst>
            </p:cNvPr>
            <p:cNvGrpSpPr/>
            <p:nvPr/>
          </p:nvGrpSpPr>
          <p:grpSpPr>
            <a:xfrm>
              <a:off x="4392012" y="3240788"/>
              <a:ext cx="2502109" cy="2993498"/>
              <a:chOff x="7880878" y="1136071"/>
              <a:chExt cx="3487837" cy="3588039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35D51F49-A555-4E61-A56A-3B46B659A0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381" t="2160" r="1125" b="3182"/>
              <a:stretch/>
            </p:blipFill>
            <p:spPr>
              <a:xfrm>
                <a:off x="8146473" y="1136071"/>
                <a:ext cx="3222242" cy="3588039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BC9F93A0-C113-4A8D-8F2C-14EB0F6CB1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79" t="4475" r="66567" b="86997"/>
              <a:stretch/>
            </p:blipFill>
            <p:spPr>
              <a:xfrm>
                <a:off x="7880878" y="1136071"/>
                <a:ext cx="1911927" cy="323273"/>
              </a:xfrm>
              <a:prstGeom prst="rect">
                <a:avLst/>
              </a:prstGeom>
            </p:spPr>
          </p:pic>
        </p:grpSp>
      </p:grpSp>
      <p:sp>
        <p:nvSpPr>
          <p:cNvPr id="13" name="矩形 12">
            <a:extLst>
              <a:ext uri="{FF2B5EF4-FFF2-40B4-BE49-F238E27FC236}">
                <a16:creationId xmlns:a16="http://schemas.microsoft.com/office/drawing/2014/main" id="{2CDDCC66-ADE3-4A03-B818-A98407C910DD}"/>
              </a:ext>
            </a:extLst>
          </p:cNvPr>
          <p:cNvSpPr/>
          <p:nvPr/>
        </p:nvSpPr>
        <p:spPr>
          <a:xfrm>
            <a:off x="4269797" y="137962"/>
            <a:ext cx="35637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kern="100" dirty="0">
                <a:latin typeface="Times New Roman" panose="02020603050405020304" pitchFamily="18" charset="0"/>
              </a:rPr>
              <a:t>Figure S3. KEGG </a:t>
            </a:r>
            <a:r>
              <a:rPr lang="en-US" altLang="zh-CN" kern="100" dirty="0" err="1">
                <a:latin typeface="Times New Roman" panose="02020603050405020304" pitchFamily="18" charset="0"/>
              </a:rPr>
              <a:t>Pathview</a:t>
            </a:r>
            <a:r>
              <a:rPr lang="en-US" altLang="zh-CN" kern="100" dirty="0">
                <a:latin typeface="Times New Roman" panose="02020603050405020304" pitchFamily="18" charset="0"/>
              </a:rPr>
              <a:t> analysi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77111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24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欣桐</dc:creator>
  <cp:lastModifiedBy>user</cp:lastModifiedBy>
  <cp:revision>7</cp:revision>
  <dcterms:created xsi:type="dcterms:W3CDTF">2024-05-16T13:04:05Z</dcterms:created>
  <dcterms:modified xsi:type="dcterms:W3CDTF">2024-05-22T17:04:24Z</dcterms:modified>
</cp:coreProperties>
</file>